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68" d="100"/>
          <a:sy n="68" d="100"/>
        </p:scale>
        <p:origin x="235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0FF028-938C-61A5-F50F-3BCC5AABCE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B0B5AE-D118-FD23-571B-F36529BD44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A5278-1DDE-824F-66BE-86BAA494B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6A045-3F43-7E14-DC2D-EE6EB912A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748CC8-3FD4-59DD-75C8-33EABBBB6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588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3921C-F13A-0AB0-805A-079B15D872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D77666-519D-A6D0-F3B9-28A57052A4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9A6787-E6A0-9418-CF80-03B4BE42F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B91B3-CCF3-32B4-0559-DA2B7BACE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BAE415-FB6F-6807-5A4D-207A345D5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8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A7BE79-4429-745C-8DA7-F3F67F174E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84A92D-9ED9-AB22-3E17-1EA40A1431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F872-BFB2-F48E-2AD6-99D4ACEBC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BD4C2E-D93F-D16E-3A15-9D416A30A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EF78D9-CB07-B69E-634E-6562EC0977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22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26626-F871-1C6D-B4AC-FE1E06767C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44AA8C-84BC-F563-3BCA-E15C4CA398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8B331E-5480-9B29-66D1-9790CCBB2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007EEF-A6E9-379E-D660-C9FB52EA7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5A3C18-1497-7A2D-06C2-82CE1B069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100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63F505-08F4-E7BB-CA79-2481CCA58C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EFD97A-FD87-5AE1-06FF-11B7EBBEEF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A89735-1E8C-0D65-D259-069E28B10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4E2C99-D784-F882-630E-C5A5D5B73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0D07AF-C2EF-E83A-66FA-DB15EA079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595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A75AD-69C5-5BB3-0C71-E2FEE9B280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2D6155-9B26-0DB4-2611-36829BD28C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066E29-3FE1-FEBE-F324-0DAA3D8406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AB4CB9-4955-5D34-1899-5E2FEF2F41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20D7A2-363B-2B79-691A-1F1A0FCF5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43D94F-DC61-6F49-F067-CFCB2BE00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198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5E3064-3AD4-2FDB-1487-3827FF7220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BCCABB-EBB7-4E3D-CC48-938BADA505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4F80DB-9A39-799B-912C-CC81EB857B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9DA480-5356-5C44-9FBE-48CCD1B5F3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5CC8185-96D4-5CBF-1712-F2E3E8C49C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08A708-9A6D-7114-E544-D50519BC1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AA6FDB-219D-849F-AB7C-5D0F1C7D9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DDD442-91AE-DEC1-682C-8D4E917EBE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385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B0D22-B3A0-C4B9-AED2-6BB9710AFD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3A47251-BCF0-FE2C-ADC2-C3EE6D0FE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3881CB2-CAB4-96ED-0A72-7CE6F55CD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118DDC-DCE3-1FDB-20DB-9C446987C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285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E076FD8-5931-75B9-48DF-A850A7510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237EE55-C00B-1AEB-A5BE-76369FF61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33F526-D0EE-DE50-B34C-E47605E66C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24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AF45F-5B14-5B5A-8BB8-E9A2FA6A02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14A941-16CB-9DD2-F596-71F28ED130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57E1F2-CF88-BF20-1AC8-BCE469DA60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BFFDF6-150B-CD6F-939A-E5F5462CA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840FB9-DE9F-3074-08A7-BA8D7396A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E9F816-4BC4-8F39-6CE8-78B29EF2F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105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89768-06A4-72C4-C891-35C6E2CD68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6EDAA70-4611-8F99-7258-45C953C057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8C01A2-1FAA-64C4-2A15-DE2C20B0EC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97FFD9-C1A1-E823-A13C-136C587A1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33E50C-DAD5-3BFF-E708-1E078C2C6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B4E282-B2A8-6AFE-0A23-8E9BAB5DF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797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7CA8ED-B80C-EDE0-17B7-F780361A21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7390B7-C790-FBE8-2C93-04AD8AC588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D42261-B4C6-CC31-D3E3-F52A48287D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93DEB0-4DB1-407A-9941-2503A9FEB54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EFCEEF-9570-EFE2-A0D2-1D67F7940F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924C48-B656-B542-91CF-D94920FF2F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BBD8EB-F057-4D03-B47D-52E525661E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514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02AA397-079F-A7E7-4630-2D385E0C21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068" y="980010"/>
            <a:ext cx="6711864" cy="272639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DD797A6-EA63-497D-BAE8-28B8877B3A14}"/>
              </a:ext>
            </a:extLst>
          </p:cNvPr>
          <p:cNvSpPr txBox="1"/>
          <p:nvPr/>
        </p:nvSpPr>
        <p:spPr>
          <a:xfrm>
            <a:off x="431208" y="3858728"/>
            <a:ext cx="5995584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anose="02020603050405020304" pitchFamily="18" charset="0"/>
              </a:rPr>
              <a:t>Supplementary Fig. S1: Flow cytometry gating strategy for analysis of CAR surface expression in THP-1 cells. </a:t>
            </a:r>
            <a:r>
              <a:rPr lang="en-US" sz="1200" dirty="0">
                <a:cs typeface="Times New Roman" panose="02020603050405020304" pitchFamily="18" charset="0"/>
              </a:rPr>
              <a:t>Representative flow cytometry plots illustrating the gating strategy used for analysis of CAR expression. Left panel</a:t>
            </a:r>
            <a:r>
              <a:rPr lang="en-US" sz="1200" b="1" dirty="0">
                <a:cs typeface="Times New Roman" panose="02020603050405020304" pitchFamily="18" charset="0"/>
              </a:rPr>
              <a:t>:</a:t>
            </a:r>
            <a:r>
              <a:rPr lang="en-US" sz="1200" dirty="0">
                <a:cs typeface="Times New Roman" panose="02020603050405020304" pitchFamily="18" charset="0"/>
              </a:rPr>
              <a:t> Forward scatter area (FSC-A) versus side scatter area (SSC-A) was used to gate the main THP-1 cell population and exclude debris. Middle panel</a:t>
            </a:r>
            <a:r>
              <a:rPr lang="en-US" sz="1200" b="1" dirty="0">
                <a:cs typeface="Times New Roman" panose="02020603050405020304" pitchFamily="18" charset="0"/>
              </a:rPr>
              <a:t>:</a:t>
            </a:r>
            <a:r>
              <a:rPr lang="en-US" sz="1200" dirty="0">
                <a:cs typeface="Times New Roman" panose="02020603050405020304" pitchFamily="18" charset="0"/>
              </a:rPr>
              <a:t> FSC-A versus FSC-H was used to identify and gate single cells, excluding doublets and aggregates. Right panel</a:t>
            </a:r>
            <a:r>
              <a:rPr lang="en-US" sz="1200" b="1" dirty="0">
                <a:cs typeface="Times New Roman" panose="02020603050405020304" pitchFamily="18" charset="0"/>
              </a:rPr>
              <a:t>:</a:t>
            </a:r>
            <a:r>
              <a:rPr lang="en-US" sz="1200" dirty="0">
                <a:cs typeface="Times New Roman" panose="02020603050405020304" pitchFamily="18" charset="0"/>
              </a:rPr>
              <a:t> Histogram of compensated AlexaFluor-488 signal showing the gate used to define Fc-positive cells; the positivity threshold was set based on untransduced THP-1 controls and applied uniformly across all samples. The percentage of AlexaFluor-488–positive cells within the single-cell gate was used for quantification of CAR surface expression.</a:t>
            </a:r>
            <a:endParaRPr lang="en-US" sz="1200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6352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46E64CB-5113-08C4-65DA-ED62E3308C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3667"/>
            <a:ext cx="6531678" cy="577827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96AFEF6-1E1E-638E-56B1-D44E87888C58}"/>
              </a:ext>
            </a:extLst>
          </p:cNvPr>
          <p:cNvSpPr txBox="1"/>
          <p:nvPr/>
        </p:nvSpPr>
        <p:spPr>
          <a:xfrm>
            <a:off x="397934" y="6254935"/>
            <a:ext cx="6303078" cy="2123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dirty="0">
                <a:cs typeface="Times New Roman" panose="02020603050405020304" pitchFamily="18" charset="0"/>
              </a:rPr>
              <a:t>Supplementary Fig. S2: Flow cytometry analysis of CAR surface expression across single-cell clones derived from CARM-2 and CARM-5 populations.</a:t>
            </a:r>
          </a:p>
          <a:p>
            <a:pPr>
              <a:buNone/>
            </a:pPr>
            <a:r>
              <a:rPr lang="en-US" sz="1200" dirty="0">
                <a:cs typeface="Times New Roman" panose="02020603050405020304" pitchFamily="18" charset="0"/>
              </a:rPr>
              <a:t>Using the gating strategy described in supplementary</a:t>
            </a:r>
            <a:r>
              <a:rPr lang="en-US" sz="1200" b="1" dirty="0">
                <a:cs typeface="Times New Roman" panose="02020603050405020304" pitchFamily="18" charset="0"/>
              </a:rPr>
              <a:t> Fig S1</a:t>
            </a:r>
            <a:r>
              <a:rPr lang="en-US" sz="1200" dirty="0">
                <a:cs typeface="Times New Roman" panose="02020603050405020304" pitchFamily="18" charset="0"/>
              </a:rPr>
              <a:t>, single-cell clones derived from CARM-2 (top panels) and CARM-5 (bottom panels) populations were analyzed for CAR surface expression by flow cytometry. Overlaid histograms show compensated AlexaFluor-488 fluorescence following staining with an AlexaFluor-488–conjugated anti-human Fc antibody, normalized to mode to facilitate comparison of expression profiles across individual clones. An antibody-stained untransduced THP-1 control was included to define background fluorescence and establish the positivity threshold. These data illustrate clone-to-clone variability in CAR surface expression within each CARM population and were used to select representative clones for downstream functional analyses.</a:t>
            </a:r>
          </a:p>
        </p:txBody>
      </p:sp>
    </p:spTree>
    <p:extLst>
      <p:ext uri="{BB962C8B-B14F-4D97-AF65-F5344CB8AC3E}">
        <p14:creationId xmlns:p14="http://schemas.microsoft.com/office/powerpoint/2010/main" val="4220199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82E2A80-0C7D-6FFB-B7D6-37A1AFBD2BE6}"/>
              </a:ext>
            </a:extLst>
          </p:cNvPr>
          <p:cNvSpPr txBox="1"/>
          <p:nvPr/>
        </p:nvSpPr>
        <p:spPr>
          <a:xfrm>
            <a:off x="507037" y="6568222"/>
            <a:ext cx="6092282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dirty="0">
                <a:cs typeface="Times New Roman" panose="02020603050405020304" pitchFamily="18" charset="0"/>
              </a:rPr>
              <a:t>Supplementary Fig. S3: Quantification of CAR surface expression across individual single-cell clones derived from CARM-2 and CARM-5 populations.</a:t>
            </a:r>
          </a:p>
          <a:p>
            <a:pPr>
              <a:buNone/>
            </a:pPr>
            <a:r>
              <a:rPr lang="en-US" sz="1200" dirty="0">
                <a:cs typeface="Times New Roman" panose="02020603050405020304" pitchFamily="18" charset="0"/>
              </a:rPr>
              <a:t>Using the gating strategy described in supplementary</a:t>
            </a:r>
            <a:r>
              <a:rPr lang="en-US" sz="1200" b="1" dirty="0">
                <a:cs typeface="Times New Roman" panose="02020603050405020304" pitchFamily="18" charset="0"/>
              </a:rPr>
              <a:t> Fig S1</a:t>
            </a:r>
            <a:r>
              <a:rPr lang="en-US" sz="1200" dirty="0">
                <a:cs typeface="Times New Roman" panose="02020603050405020304" pitchFamily="18" charset="0"/>
              </a:rPr>
              <a:t>, single-cell clones derived from CARM-2 (top panels) and CARM-5 (bottom panels) populations were analyzed for CAR surface expression by flow cytometry following staining with an AlexaFluor-488–conjugated anti-human Fc antibody. Left panels show the percentage of AlexaFluor-488–positive cells within each clone, while right panels show the corresponding mean fluorescence intensity (MFI) of the AlexaFluor-488 signal within the positive population. Untransduced THP-1 cells are included as a negative control. These data illustrate clone-to-clone variability in both the fraction of CAR-expressing cells and the level of CAR expression per cell within each CAR-M population. These metrics were used to assess relationships between CAR surface expression and functional activity, as shown in </a:t>
            </a:r>
            <a:r>
              <a:rPr lang="en-US" sz="1200" b="1" dirty="0">
                <a:cs typeface="Times New Roman" panose="02020603050405020304" pitchFamily="18" charset="0"/>
              </a:rPr>
              <a:t>Fig. 4</a:t>
            </a:r>
            <a:r>
              <a:rPr lang="en-US" sz="1200" dirty="0">
                <a:cs typeface="Times New Roman" panose="02020603050405020304" pitchFamily="18" charset="0"/>
              </a:rPr>
              <a:t>.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2B11E78-4E2C-49F7-953F-577B523902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4059252"/>
              </p:ext>
            </p:extLst>
          </p:nvPr>
        </p:nvGraphicFramePr>
        <p:xfrm>
          <a:off x="695279" y="267454"/>
          <a:ext cx="5467442" cy="59895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7257758" imgH="7945433" progId="Prism10.Document">
                  <p:embed/>
                </p:oleObj>
              </mc:Choice>
              <mc:Fallback>
                <p:oleObj name="Prism 10" r:id="rId2" imgW="7257758" imgH="794543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5279" y="267454"/>
                        <a:ext cx="5467442" cy="59895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37732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5</TotalTime>
  <Words>426</Words>
  <Application>Microsoft Office PowerPoint</Application>
  <PresentationFormat>Letter Paper (8.5x11 in)</PresentationFormat>
  <Paragraphs>5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achandran, Manasi</dc:creator>
  <cp:lastModifiedBy>Balachandran, Manasi</cp:lastModifiedBy>
  <cp:revision>20</cp:revision>
  <dcterms:created xsi:type="dcterms:W3CDTF">2026-02-06T18:13:19Z</dcterms:created>
  <dcterms:modified xsi:type="dcterms:W3CDTF">2026-02-13T17:23:22Z</dcterms:modified>
</cp:coreProperties>
</file>